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EB649-17B1-445B-9571-C75DD6D86A0D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CD626F-1705-48DB-9B8E-8CD271D165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036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F744CCC-46E9-7688-2906-12A324F57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2DF1E19-1D30-89D4-C038-FEDE434BF9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DF715-24E9-8A8D-03D4-96E49FB0F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F7D212-FB4E-F675-EFD3-6492B3520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9F96C7-42C6-CCCA-0829-A36F04128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360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6DA2BE-438E-797F-1C1B-321508971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BEDFDB-8F10-EDB3-ED47-99343C81F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A5425B-440F-ADD4-C728-D123F6596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1EB524-E65A-8996-FA1F-4D2776E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666142-4DA1-7399-0F06-0476A6A3E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1298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F8AF0EA-763F-16B9-0DA1-2272E09E12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B74AA9C-7452-6F76-BE88-1D305505E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69408A-907C-0799-8776-97D72BD96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144BAD-12EA-093A-335A-B13299F07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94DB88-4D93-7BC4-B8F7-9399EE22D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532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B264FB-8C8C-8B77-AD45-29C7A20A0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B5D888-AA6E-3A26-D001-48F00CF697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96E5FF-C1AA-6730-B077-7E7B91C28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AC8766-0527-C96E-217A-2CD34C251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0DB8C9-57DD-F3E8-4E9A-70117D53B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46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82EE6B-A62D-775F-3F06-D3874DAC6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3CD5FF-E1AE-F736-5BFD-D579B4DB8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747A06-D3D1-D637-F386-66826CCF5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E74043-957E-C976-D60F-AD4569097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9B9396-3966-D835-2CB5-CE2AEB09A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172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FF3F15-394A-2ECC-01CB-B08A1B08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3FEA71A-20FD-1D93-2A62-D320EEC63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07982C6-4AE8-FB53-07E0-6AFCF5DF1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BF801E-0B89-A306-859D-639F9F142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987191-D381-A152-4D46-19E7FA2F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51A059-5738-1494-04BC-73A8BC31E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3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ADA289-C419-CCB5-AA3F-6330512BA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7C1AE2-200E-EF2C-E95E-2675EA3CD3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A1D9646-BB54-D205-A1CD-202444DEDE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832D20-37FF-3FB8-C7C9-A9CB67018F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62B2674-B7B2-CC37-2B94-CE3865C4DA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66948B-A594-693B-E59F-F51D6B00A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13E672D-F9B8-2194-6C16-5EBC36777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DF29C2E-0210-5BD0-5EA3-65D2D3EB9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5597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A45253-0887-B3DD-F842-28DAD97BA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04FD90E-2098-89F7-4349-9CCECF2B8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6FD3444-85A2-7551-3222-C8EDB4BB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3C033D2-ABB2-D61F-4D7D-18AEF8B2E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4177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8295978-3383-F8B4-E89A-F39231445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8963890-7493-D460-EC6E-9647252BD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CC12E0-790B-C0AC-A1F4-93ADD7BB4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091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C2D9B5-06D2-7FB4-FCB5-0094753F8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5649A2F-3255-E26A-97BF-92F597DD6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899F36-8162-8267-9764-D8204C144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F124357-77FD-F663-9F0B-2799E9A89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BF5596-2FD8-DCBB-DB97-9B1B568AB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A9956F-2484-C16B-13A9-F3AAD6B94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31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49525B-C8E4-2EFD-348F-F2765DFD8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9E4EF4F-6E0F-E0F4-498F-E84DF2CB9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6B516D2-1FB0-0232-ECA2-F0E8FD7FB7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7B95E26-6710-FAE5-ACB5-78EB9EEF6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0AF0F4-D672-479D-FEC2-BA2E7F749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8355870-B977-5D17-5FED-090E7E75F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56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ED75A8E-99EC-89DF-C483-080E5096B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9ED7E6-3BAF-C655-C756-F5AD71F91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F231B9-161B-1F68-EF20-68883F3C1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73CDC17-BAAD-52F6-17C1-0C5A1C086B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632462-D74A-B7A4-69E6-6281B32C99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42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2A2E870E-CD61-4FF7-B497-9171643000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2062162"/>
            <a:ext cx="6858000" cy="2733675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618829DA-A0C3-2768-B979-B15E983893D1}"/>
              </a:ext>
            </a:extLst>
          </p:cNvPr>
          <p:cNvSpPr txBox="1"/>
          <p:nvPr/>
        </p:nvSpPr>
        <p:spPr>
          <a:xfrm>
            <a:off x="84836" y="72034"/>
            <a:ext cx="24551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Meta-Régression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nfluenc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smoking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hysician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ver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as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fr-FR" sz="1400" b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78823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-Louis Naillon</dc:creator>
  <cp:lastModifiedBy>Pierre-Louis Naillon</cp:lastModifiedBy>
  <cp:revision>17</cp:revision>
  <dcterms:created xsi:type="dcterms:W3CDTF">2022-05-30T15:13:49Z</dcterms:created>
  <dcterms:modified xsi:type="dcterms:W3CDTF">2023-04-26T20:02:01Z</dcterms:modified>
</cp:coreProperties>
</file>